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64" r:id="rId2"/>
    <p:sldId id="265" r:id="rId3"/>
    <p:sldId id="261" r:id="rId4"/>
    <p:sldId id="266" r:id="rId5"/>
    <p:sldId id="258" r:id="rId6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524"/>
    <p:restoredTop sz="94658"/>
  </p:normalViewPr>
  <p:slideViewPr>
    <p:cSldViewPr snapToGrid="0">
      <p:cViewPr varScale="1">
        <p:scale>
          <a:sx n="104" d="100"/>
          <a:sy n="104" d="100"/>
        </p:scale>
        <p:origin x="150" y="12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044101-9ABD-904F-8DAF-BB8883C0C855}" type="datetimeFigureOut">
              <a:rPr lang="de-DE" smtClean="0"/>
              <a:t>21.07.2025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746AE04-DEF0-5444-9CED-1D941BB8992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465969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7C7A73A-61D8-31FD-D83C-EE503D3B8FB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D9603251-F56D-D321-6AD3-5ACE4797FC9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6F6BA14-25B1-40B1-8E85-109E08A4FF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8BB81-B107-CD42-96E2-7747CF6337DF}" type="datetimeFigureOut">
              <a:rPr lang="de-DE" smtClean="0"/>
              <a:t>21.07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12A76BB-1DDD-6B80-59C7-1042686D37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3C07691-CF11-F96E-E80D-46A2CA414F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A9C29-DF84-714D-9D2A-81431CCE69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306300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93C0C39-6E39-DE48-815A-9B6B71D0BF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ACA85907-1AF2-B7D7-270A-10AA0B9E07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5720AAD-6563-7E9F-078F-BDFDB7E10B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8BB81-B107-CD42-96E2-7747CF6337DF}" type="datetimeFigureOut">
              <a:rPr lang="de-DE" smtClean="0"/>
              <a:t>21.07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1AB4958-B7E1-5FFB-9AB2-E90D2FD010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E100531-A256-9122-884F-37346147CA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A9C29-DF84-714D-9D2A-81431CCE69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288401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78A7368D-0EC6-EE1C-0026-DB25F6E48F0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DD1B7A90-BD90-CE56-65F7-146D586BD1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FD6B26C-D6B8-FCA4-068B-6DACEBE04A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8BB81-B107-CD42-96E2-7747CF6337DF}" type="datetimeFigureOut">
              <a:rPr lang="de-DE" smtClean="0"/>
              <a:t>21.07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D8A25D4-8FBF-C254-B666-F575902A27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5BF3446-20BE-B1A5-4443-A2AB243E0D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A9C29-DF84-714D-9D2A-81431CCE69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403404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54CE92F-3F7F-9932-1BE6-E8C7CB43F3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480B814-5E1D-238D-2F77-5CBAA53B117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13DB4DC-FEA4-3DBE-8323-038414A2E5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8BB81-B107-CD42-96E2-7747CF6337DF}" type="datetimeFigureOut">
              <a:rPr lang="de-DE" smtClean="0"/>
              <a:t>21.07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00CDBBF-05AB-4FE4-B457-A99A9F4FE6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352572D-6F95-BEF0-B899-77A31F6D97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A9C29-DF84-714D-9D2A-81431CCE69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904389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72F84C1-DC9D-67E8-AC0F-B5D49A2F1F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50491B30-4740-E431-AFB5-0E77A046E5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C1B67F5-54B4-1CFA-9923-779D88583F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8BB81-B107-CD42-96E2-7747CF6337DF}" type="datetimeFigureOut">
              <a:rPr lang="de-DE" smtClean="0"/>
              <a:t>21.07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F05299B-1E7C-A2E1-A4B5-7BCD545FC0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C86135B-369B-DB26-29C8-EE795FFAAA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A9C29-DF84-714D-9D2A-81431CCE69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769102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00436EB-98F3-DD01-5970-9F838AC719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0B8D2E25-A598-44B9-DCC5-8656C117ADB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25114B64-E1EC-8042-547A-94ED51A5318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3EFA2FA-C0C6-FEA6-316D-F0E454C8B5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8BB81-B107-CD42-96E2-7747CF6337DF}" type="datetimeFigureOut">
              <a:rPr lang="de-DE" smtClean="0"/>
              <a:t>21.07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75574570-2739-6317-AA21-33DD9FB465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4DF1254C-BA96-847B-849E-C6B6A02915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A9C29-DF84-714D-9D2A-81431CCE69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295001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216E208-BB59-9CC1-445C-AC93560563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739C2B17-44D2-B85C-50B1-BC2B61771A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90A7EBFB-32D3-F64F-922D-3148D6AD9CC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03805D0F-60D0-CCDE-99F2-46B941EA25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F8D71305-A9CE-8879-6BD6-D880AA65D23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B9198C50-1D92-D114-9E29-E784102F52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8BB81-B107-CD42-96E2-7747CF6337DF}" type="datetimeFigureOut">
              <a:rPr lang="de-DE" smtClean="0"/>
              <a:t>21.07.20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97E130D4-16E1-FAF0-76E2-A17ABC8885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B531E65F-F8C1-9E7E-FB0D-1EBE404522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A9C29-DF84-714D-9D2A-81431CCE69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85461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00F4CF9-3209-D526-CE25-D7D8EF42D0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3D0D97E2-FDDE-654B-DC4C-D3EA140076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8BB81-B107-CD42-96E2-7747CF6337DF}" type="datetimeFigureOut">
              <a:rPr lang="de-DE" smtClean="0"/>
              <a:t>21.07.20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6F698957-8930-A0A5-2C19-AE1D245B06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4C142000-FE09-62EA-49CE-87EC11CAB9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A9C29-DF84-714D-9D2A-81431CCE69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093743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CA6380F8-585D-E5FD-BD54-3D52B1EF3B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8BB81-B107-CD42-96E2-7747CF6337DF}" type="datetimeFigureOut">
              <a:rPr lang="de-DE" smtClean="0"/>
              <a:t>21.07.20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B2BD80B3-5BBE-39EA-FC04-3F6CEDEC10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AC59ED5D-FBA3-1EBB-1C6E-D40B215E8F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A9C29-DF84-714D-9D2A-81431CCE69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826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D20A46A-E5BC-8E4B-89B5-B40E6809F5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906DE02-429C-B297-D4AB-EA54E9326B4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14F0881C-5340-88DC-9D14-6C2057E9D21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F84B8FFF-5220-B19B-B7F5-FA4FBC2999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8BB81-B107-CD42-96E2-7747CF6337DF}" type="datetimeFigureOut">
              <a:rPr lang="de-DE" smtClean="0"/>
              <a:t>21.07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9968D7D1-8579-DB5F-F4F6-19EC88F47B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8D839374-2F5B-FF8F-AE2F-4447F206A3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A9C29-DF84-714D-9D2A-81431CCE69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252993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CB438AD-F48C-CF31-066E-3D6CF41FE0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96E52331-0972-32D3-9972-0974C946410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6328B5BE-5944-AA71-FBDD-9A05E64F4D4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C34ACE1F-7D44-0538-C837-1DFDA69BCF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8BB81-B107-CD42-96E2-7747CF6337DF}" type="datetimeFigureOut">
              <a:rPr lang="de-DE" smtClean="0"/>
              <a:t>21.07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22205D9-6885-31A7-5ED4-5099012AD8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BE4BB3B-1B24-05B5-AB84-54D52EABE6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A9C29-DF84-714D-9D2A-81431CCE69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738013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B9C1C165-474B-CD02-31B5-C856773687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39135D83-1A88-80C1-64A6-A4A36BCF33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774B523-0F8A-5FA4-EE37-FC03A647DEA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E58BB81-B107-CD42-96E2-7747CF6337DF}" type="datetimeFigureOut">
              <a:rPr lang="de-DE" smtClean="0"/>
              <a:t>21.07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D7FD6A1-68D5-AB17-E106-4F0571BB3B1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D9B8D0B-28D4-D01A-E51F-827CBBBBE68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21A9C29-DF84-714D-9D2A-81431CCE69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724092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CF2EC2F8-9A78-402D-96D5-23CF2C311D8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48186" y="561189"/>
            <a:ext cx="5761219" cy="2493480"/>
          </a:xfrm>
          <a:prstGeom prst="rect">
            <a:avLst/>
          </a:prstGeom>
        </p:spPr>
      </p:pic>
      <p:pic>
        <p:nvPicPr>
          <p:cNvPr id="4" name="Grafik 3">
            <a:extLst>
              <a:ext uri="{FF2B5EF4-FFF2-40B4-BE49-F238E27FC236}">
                <a16:creationId xmlns:a16="http://schemas.microsoft.com/office/drawing/2014/main" id="{5772B3E6-814C-4BF3-A413-8461EB5840C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48186" y="3473786"/>
            <a:ext cx="5767316" cy="2530059"/>
          </a:xfrm>
          <a:prstGeom prst="rect">
            <a:avLst/>
          </a:prstGeom>
        </p:spPr>
      </p:pic>
      <p:sp>
        <p:nvSpPr>
          <p:cNvPr id="7" name="Rechteck 6">
            <a:extLst>
              <a:ext uri="{FF2B5EF4-FFF2-40B4-BE49-F238E27FC236}">
                <a16:creationId xmlns:a16="http://schemas.microsoft.com/office/drawing/2014/main" id="{B39387B6-7BC0-4C6B-80C6-68BF55402802}"/>
              </a:ext>
            </a:extLst>
          </p:cNvPr>
          <p:cNvSpPr/>
          <p:nvPr/>
        </p:nvSpPr>
        <p:spPr>
          <a:xfrm>
            <a:off x="0" y="6488668"/>
            <a:ext cx="26295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material 1 </a:t>
            </a:r>
            <a:endParaRPr lang="de-DE" dirty="0"/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A23A45F1-321F-4D79-964B-4797E7E9C470}"/>
              </a:ext>
            </a:extLst>
          </p:cNvPr>
          <p:cNvSpPr txBox="1"/>
          <p:nvPr/>
        </p:nvSpPr>
        <p:spPr>
          <a:xfrm>
            <a:off x="387092" y="56118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A1CCE606-5E45-43FD-AF26-E67A04C1855E}"/>
              </a:ext>
            </a:extLst>
          </p:cNvPr>
          <p:cNvSpPr txBox="1"/>
          <p:nvPr/>
        </p:nvSpPr>
        <p:spPr>
          <a:xfrm>
            <a:off x="404003" y="342900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1421285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>
            <a:extLst>
              <a:ext uri="{FF2B5EF4-FFF2-40B4-BE49-F238E27FC236}">
                <a16:creationId xmlns:a16="http://schemas.microsoft.com/office/drawing/2014/main" id="{E2833148-C9BE-4904-BA44-56AFA0BDECE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59493195"/>
              </p:ext>
            </p:extLst>
          </p:nvPr>
        </p:nvGraphicFramePr>
        <p:xfrm>
          <a:off x="2194588" y="1173803"/>
          <a:ext cx="7802823" cy="456816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389750">
                  <a:extLst>
                    <a:ext uri="{9D8B030D-6E8A-4147-A177-3AD203B41FA5}">
                      <a16:colId xmlns:a16="http://schemas.microsoft.com/office/drawing/2014/main" val="188368539"/>
                    </a:ext>
                  </a:extLst>
                </a:gridCol>
                <a:gridCol w="2558303">
                  <a:extLst>
                    <a:ext uri="{9D8B030D-6E8A-4147-A177-3AD203B41FA5}">
                      <a16:colId xmlns:a16="http://schemas.microsoft.com/office/drawing/2014/main" val="697786697"/>
                    </a:ext>
                  </a:extLst>
                </a:gridCol>
                <a:gridCol w="1854770">
                  <a:extLst>
                    <a:ext uri="{9D8B030D-6E8A-4147-A177-3AD203B41FA5}">
                      <a16:colId xmlns:a16="http://schemas.microsoft.com/office/drawing/2014/main" val="1919544"/>
                    </a:ext>
                  </a:extLst>
                </a:gridCol>
              </a:tblGrid>
              <a:tr h="815319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2400" u="none" strike="noStrike" dirty="0" err="1">
                          <a:effectLst/>
                        </a:rPr>
                        <a:t>precursor</a:t>
                      </a:r>
                      <a:r>
                        <a:rPr lang="de-DE" sz="2400" u="none" strike="noStrike" dirty="0">
                          <a:effectLst/>
                        </a:rPr>
                        <a:t> N188 </a:t>
                      </a:r>
                      <a:r>
                        <a:rPr lang="de-DE" sz="2400" u="none" strike="noStrike" dirty="0" err="1">
                          <a:effectLst/>
                        </a:rPr>
                        <a:t>reaction</a:t>
                      </a:r>
                      <a:r>
                        <a:rPr lang="de-DE" sz="2400" u="none" strike="noStrike" dirty="0">
                          <a:effectLst/>
                        </a:rPr>
                        <a:t> [</a:t>
                      </a:r>
                      <a:r>
                        <a:rPr lang="de-DE" sz="2400" u="none" strike="noStrike" dirty="0" err="1">
                          <a:effectLst/>
                        </a:rPr>
                        <a:t>nmol</a:t>
                      </a:r>
                      <a:r>
                        <a:rPr lang="de-DE" sz="2400" u="none" strike="noStrike" dirty="0">
                          <a:effectLst/>
                        </a:rPr>
                        <a:t>]</a:t>
                      </a:r>
                      <a:endParaRPr lang="de-DE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2400" u="none" strike="noStrike">
                          <a:effectLst/>
                        </a:rPr>
                        <a:t>activity product purified [MBq]</a:t>
                      </a:r>
                      <a:endParaRPr lang="de-DE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2400" u="none" strike="noStrike">
                          <a:effectLst/>
                        </a:rPr>
                        <a:t>MBq/nmol</a:t>
                      </a:r>
                      <a:endParaRPr lang="de-DE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250228510"/>
                  </a:ext>
                </a:extLst>
              </a:tr>
              <a:tr h="284413">
                <a:tc>
                  <a:txBody>
                    <a:bodyPr/>
                    <a:lstStyle/>
                    <a:p>
                      <a:pPr algn="r" fontAlgn="b"/>
                      <a:r>
                        <a:rPr lang="de-DE" sz="2400" u="none" strike="noStrike" dirty="0">
                          <a:effectLst/>
                        </a:rPr>
                        <a:t>10</a:t>
                      </a:r>
                      <a:endParaRPr lang="de-DE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2400" u="none" strike="noStrike">
                          <a:effectLst/>
                        </a:rPr>
                        <a:t>682</a:t>
                      </a:r>
                      <a:endParaRPr lang="de-DE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2400" u="none" strike="noStrike">
                          <a:effectLst/>
                        </a:rPr>
                        <a:t>68,2</a:t>
                      </a:r>
                      <a:endParaRPr lang="de-DE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0104478"/>
                  </a:ext>
                </a:extLst>
              </a:tr>
              <a:tr h="284413">
                <a:tc>
                  <a:txBody>
                    <a:bodyPr/>
                    <a:lstStyle/>
                    <a:p>
                      <a:pPr algn="r" fontAlgn="b"/>
                      <a:r>
                        <a:rPr lang="de-DE" sz="2400" u="none" strike="noStrike" dirty="0">
                          <a:effectLst/>
                        </a:rPr>
                        <a:t>10</a:t>
                      </a:r>
                      <a:endParaRPr lang="de-DE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2400" u="none" strike="noStrike" dirty="0">
                          <a:effectLst/>
                        </a:rPr>
                        <a:t>682</a:t>
                      </a:r>
                      <a:endParaRPr lang="de-DE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2400" u="none" strike="noStrike">
                          <a:effectLst/>
                        </a:rPr>
                        <a:t>68,2</a:t>
                      </a:r>
                      <a:endParaRPr lang="de-DE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21251919"/>
                  </a:ext>
                </a:extLst>
              </a:tr>
              <a:tr h="284413">
                <a:tc>
                  <a:txBody>
                    <a:bodyPr/>
                    <a:lstStyle/>
                    <a:p>
                      <a:pPr algn="r" fontAlgn="b"/>
                      <a:r>
                        <a:rPr lang="de-DE" sz="2400" u="none" strike="noStrike">
                          <a:effectLst/>
                        </a:rPr>
                        <a:t>4</a:t>
                      </a:r>
                      <a:endParaRPr lang="de-DE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2400" u="none" strike="noStrike" dirty="0">
                          <a:effectLst/>
                        </a:rPr>
                        <a:t>864</a:t>
                      </a:r>
                      <a:endParaRPr lang="de-DE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2400" u="none" strike="noStrike">
                          <a:effectLst/>
                        </a:rPr>
                        <a:t>216</a:t>
                      </a:r>
                      <a:endParaRPr lang="de-DE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25207452"/>
                  </a:ext>
                </a:extLst>
              </a:tr>
              <a:tr h="284413">
                <a:tc>
                  <a:txBody>
                    <a:bodyPr/>
                    <a:lstStyle/>
                    <a:p>
                      <a:pPr algn="r" fontAlgn="b"/>
                      <a:r>
                        <a:rPr lang="de-DE" sz="2400" u="none" strike="noStrike" dirty="0">
                          <a:effectLst/>
                        </a:rPr>
                        <a:t>4</a:t>
                      </a:r>
                      <a:endParaRPr lang="de-DE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2400" u="none" strike="noStrike" dirty="0">
                          <a:effectLst/>
                        </a:rPr>
                        <a:t>864</a:t>
                      </a:r>
                      <a:endParaRPr lang="de-DE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2400" u="none" strike="noStrike">
                          <a:effectLst/>
                        </a:rPr>
                        <a:t>216</a:t>
                      </a:r>
                      <a:endParaRPr lang="de-DE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35864946"/>
                  </a:ext>
                </a:extLst>
              </a:tr>
              <a:tr h="284413">
                <a:tc>
                  <a:txBody>
                    <a:bodyPr/>
                    <a:lstStyle/>
                    <a:p>
                      <a:pPr algn="r" fontAlgn="b"/>
                      <a:r>
                        <a:rPr lang="de-DE" sz="2400" u="none" strike="noStrike">
                          <a:effectLst/>
                        </a:rPr>
                        <a:t>20</a:t>
                      </a:r>
                      <a:endParaRPr lang="de-DE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2400" u="none" strike="noStrike" dirty="0">
                          <a:effectLst/>
                        </a:rPr>
                        <a:t>94</a:t>
                      </a:r>
                      <a:endParaRPr lang="de-DE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2400" u="none" strike="noStrike">
                          <a:effectLst/>
                        </a:rPr>
                        <a:t>4,7</a:t>
                      </a:r>
                      <a:endParaRPr lang="de-DE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54670430"/>
                  </a:ext>
                </a:extLst>
              </a:tr>
              <a:tr h="284413">
                <a:tc>
                  <a:txBody>
                    <a:bodyPr/>
                    <a:lstStyle/>
                    <a:p>
                      <a:pPr algn="r" fontAlgn="b"/>
                      <a:r>
                        <a:rPr lang="de-DE" sz="2400" u="none" strike="noStrike">
                          <a:effectLst/>
                        </a:rPr>
                        <a:t>20</a:t>
                      </a:r>
                      <a:endParaRPr lang="de-DE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2400" u="none" strike="noStrike" dirty="0">
                          <a:effectLst/>
                        </a:rPr>
                        <a:t>298</a:t>
                      </a:r>
                      <a:endParaRPr lang="de-DE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2400" u="none" strike="noStrike">
                          <a:effectLst/>
                        </a:rPr>
                        <a:t>14,9</a:t>
                      </a:r>
                      <a:endParaRPr lang="de-DE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37526830"/>
                  </a:ext>
                </a:extLst>
              </a:tr>
              <a:tr h="284413">
                <a:tc>
                  <a:txBody>
                    <a:bodyPr/>
                    <a:lstStyle/>
                    <a:p>
                      <a:pPr algn="r" fontAlgn="b"/>
                      <a:r>
                        <a:rPr lang="de-DE" sz="2400" u="none" strike="noStrike">
                          <a:effectLst/>
                        </a:rPr>
                        <a:t>20</a:t>
                      </a:r>
                      <a:endParaRPr lang="de-DE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2400" u="none" strike="noStrike" dirty="0">
                          <a:effectLst/>
                        </a:rPr>
                        <a:t>298</a:t>
                      </a:r>
                      <a:endParaRPr lang="de-DE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2400" u="none" strike="noStrike" dirty="0">
                          <a:effectLst/>
                        </a:rPr>
                        <a:t>14,9</a:t>
                      </a:r>
                      <a:endParaRPr lang="de-DE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26188179"/>
                  </a:ext>
                </a:extLst>
              </a:tr>
              <a:tr h="284413">
                <a:tc>
                  <a:txBody>
                    <a:bodyPr/>
                    <a:lstStyle/>
                    <a:p>
                      <a:pPr algn="r" fontAlgn="b"/>
                      <a:r>
                        <a:rPr lang="de-DE" sz="2400" u="none" strike="noStrike">
                          <a:effectLst/>
                        </a:rPr>
                        <a:t>20</a:t>
                      </a:r>
                      <a:endParaRPr lang="de-DE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2400" u="none" strike="noStrike">
                          <a:effectLst/>
                        </a:rPr>
                        <a:t>72</a:t>
                      </a:r>
                      <a:endParaRPr lang="de-DE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2400" u="none" strike="noStrike" dirty="0">
                          <a:effectLst/>
                        </a:rPr>
                        <a:t>3,6</a:t>
                      </a:r>
                      <a:endParaRPr lang="de-DE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04444906"/>
                  </a:ext>
                </a:extLst>
              </a:tr>
              <a:tr h="284413">
                <a:tc>
                  <a:txBody>
                    <a:bodyPr/>
                    <a:lstStyle/>
                    <a:p>
                      <a:pPr algn="r" fontAlgn="b"/>
                      <a:r>
                        <a:rPr lang="de-DE" sz="2400" u="none" strike="noStrike">
                          <a:effectLst/>
                        </a:rPr>
                        <a:t>10</a:t>
                      </a:r>
                      <a:endParaRPr lang="de-DE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2400" u="none" strike="noStrike">
                          <a:effectLst/>
                        </a:rPr>
                        <a:t>136</a:t>
                      </a:r>
                      <a:endParaRPr lang="de-DE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2400" u="none" strike="noStrike" dirty="0">
                          <a:effectLst/>
                        </a:rPr>
                        <a:t>13,6</a:t>
                      </a:r>
                      <a:endParaRPr lang="de-DE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17146327"/>
                  </a:ext>
                </a:extLst>
              </a:tr>
              <a:tr h="284413">
                <a:tc>
                  <a:txBody>
                    <a:bodyPr/>
                    <a:lstStyle/>
                    <a:p>
                      <a:pPr algn="r" fontAlgn="b"/>
                      <a:r>
                        <a:rPr lang="de-DE" sz="2400" u="none" strike="noStrike">
                          <a:effectLst/>
                        </a:rPr>
                        <a:t>20</a:t>
                      </a:r>
                      <a:endParaRPr lang="de-DE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2400" u="none" strike="noStrike" dirty="0">
                          <a:effectLst/>
                        </a:rPr>
                        <a:t>818</a:t>
                      </a:r>
                      <a:endParaRPr lang="de-DE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2400" u="none" strike="noStrike" dirty="0">
                          <a:effectLst/>
                        </a:rPr>
                        <a:t>40,9</a:t>
                      </a:r>
                      <a:endParaRPr lang="de-DE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69061472"/>
                  </a:ext>
                </a:extLst>
              </a:tr>
            </a:tbl>
          </a:graphicData>
        </a:graphic>
      </p:graphicFrame>
      <p:sp>
        <p:nvSpPr>
          <p:cNvPr id="3" name="Rechteck 2">
            <a:extLst>
              <a:ext uri="{FF2B5EF4-FFF2-40B4-BE49-F238E27FC236}">
                <a16:creationId xmlns:a16="http://schemas.microsoft.com/office/drawing/2014/main" id="{E43A22C3-FBF9-43F1-B618-074462AB0930}"/>
              </a:ext>
            </a:extLst>
          </p:cNvPr>
          <p:cNvSpPr/>
          <p:nvPr/>
        </p:nvSpPr>
        <p:spPr>
          <a:xfrm>
            <a:off x="0" y="6488668"/>
            <a:ext cx="26295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material 2 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42198535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8165B58E-BDAC-2022-6385-DD86E458A447}"/>
              </a:ext>
            </a:extLst>
          </p:cNvPr>
          <p:cNvSpPr txBox="1"/>
          <p:nvPr/>
        </p:nvSpPr>
        <p:spPr>
          <a:xfrm>
            <a:off x="0" y="6488668"/>
            <a:ext cx="27813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material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endParaRPr lang="de-DE" dirty="0"/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3F817A33-3D73-4B23-A3DC-3313E36449DA}"/>
              </a:ext>
            </a:extLst>
          </p:cNvPr>
          <p:cNvSpPr txBox="1"/>
          <p:nvPr/>
        </p:nvSpPr>
        <p:spPr>
          <a:xfrm>
            <a:off x="676018" y="42596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941B6787-B98C-49F9-9FDD-20AAD2EF77FA}"/>
              </a:ext>
            </a:extLst>
          </p:cNvPr>
          <p:cNvSpPr txBox="1"/>
          <p:nvPr/>
        </p:nvSpPr>
        <p:spPr>
          <a:xfrm>
            <a:off x="5954927" y="42596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50D8252D-7BDA-463C-9EFA-8E509635D2C8}"/>
              </a:ext>
            </a:extLst>
          </p:cNvPr>
          <p:cNvSpPr txBox="1"/>
          <p:nvPr/>
        </p:nvSpPr>
        <p:spPr>
          <a:xfrm>
            <a:off x="3514468" y="365073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C</a:t>
            </a:r>
          </a:p>
        </p:txBody>
      </p:sp>
      <p:pic>
        <p:nvPicPr>
          <p:cNvPr id="11" name="Grafik 10">
            <a:extLst>
              <a:ext uri="{FF2B5EF4-FFF2-40B4-BE49-F238E27FC236}">
                <a16:creationId xmlns:a16="http://schemas.microsoft.com/office/drawing/2014/main" id="{262CA1EB-5951-D125-7294-FD8EBFD89F3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20651" y="425964"/>
            <a:ext cx="3714750" cy="2571750"/>
          </a:xfrm>
          <a:prstGeom prst="rect">
            <a:avLst/>
          </a:prstGeom>
        </p:spPr>
      </p:pic>
      <p:pic>
        <p:nvPicPr>
          <p:cNvPr id="12" name="Grafik 11">
            <a:extLst>
              <a:ext uri="{FF2B5EF4-FFF2-40B4-BE49-F238E27FC236}">
                <a16:creationId xmlns:a16="http://schemas.microsoft.com/office/drawing/2014/main" id="{78FE05F8-3B30-CBCD-EA1A-8D9AC1FE77B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61969" y="425964"/>
            <a:ext cx="3721100" cy="2571750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27F085F6-3548-ACB3-4E34-1E1FFE68129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88135" y="3650736"/>
            <a:ext cx="3721099" cy="25761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467763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3E9AD073-4083-4E1F-A363-DC004B12376A}"/>
              </a:ext>
            </a:extLst>
          </p:cNvPr>
          <p:cNvSpPr txBox="1"/>
          <p:nvPr/>
        </p:nvSpPr>
        <p:spPr>
          <a:xfrm>
            <a:off x="0" y="6488668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material 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</a:t>
            </a:r>
            <a:endParaRPr lang="de-DE" dirty="0"/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580C2FE3-0F58-4F47-A442-5027C24AA1B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90762" y="795337"/>
            <a:ext cx="7610475" cy="52673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76687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2C6C4495-A35C-13D5-59A7-62D09241CC84}"/>
              </a:ext>
            </a:extLst>
          </p:cNvPr>
          <p:cNvSpPr txBox="1"/>
          <p:nvPr/>
        </p:nvSpPr>
        <p:spPr>
          <a:xfrm>
            <a:off x="0" y="6488668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</a:t>
            </a:r>
            <a:r>
              <a:rPr lang="en-US" sz="1800" b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aterial </a:t>
            </a: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</a:t>
            </a:r>
            <a:endParaRPr lang="de-DE" dirty="0"/>
          </a:p>
        </p:txBody>
      </p:sp>
      <p:pic>
        <p:nvPicPr>
          <p:cNvPr id="2" name="Grafik 1">
            <a:extLst>
              <a:ext uri="{FF2B5EF4-FFF2-40B4-BE49-F238E27FC236}">
                <a16:creationId xmlns:a16="http://schemas.microsoft.com/office/drawing/2014/main" id="{BAB4D4BD-8013-0D8B-9D6A-C226153043B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51100" y="965200"/>
            <a:ext cx="7289800" cy="492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903362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5</Words>
  <Application>Microsoft Office PowerPoint</Application>
  <PresentationFormat>Breitbild</PresentationFormat>
  <Paragraphs>43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10" baseType="lpstr">
      <vt:lpstr>Aptos</vt:lpstr>
      <vt:lpstr>Aptos Display</vt:lpstr>
      <vt:lpstr>Arial</vt:lpstr>
      <vt:lpstr>Calibri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tthias Miederer</dc:creator>
  <cp:lastModifiedBy>Miederer, Matthias</cp:lastModifiedBy>
  <cp:revision>42</cp:revision>
  <dcterms:created xsi:type="dcterms:W3CDTF">2025-02-21T15:29:28Z</dcterms:created>
  <dcterms:modified xsi:type="dcterms:W3CDTF">2025-07-21T09:20:35Z</dcterms:modified>
</cp:coreProperties>
</file>